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Default Extension="jp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media/image13.jpg" ContentType="image/jpeg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75" r:id="rId2"/>
    <p:sldId id="257" r:id="rId3"/>
    <p:sldId id="276" r:id="rId4"/>
    <p:sldId id="259" r:id="rId5"/>
    <p:sldId id="260" r:id="rId6"/>
    <p:sldId id="277" r:id="rId7"/>
    <p:sldId id="262" r:id="rId8"/>
    <p:sldId id="263" r:id="rId9"/>
    <p:sldId id="278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26" autoAdjust="0"/>
    <p:restoredTop sz="94660"/>
  </p:normalViewPr>
  <p:slideViewPr>
    <p:cSldViewPr snapToGrid="0" showGuides="1">
      <p:cViewPr varScale="1">
        <p:scale>
          <a:sx n="39" d="100"/>
          <a:sy n="39" d="100"/>
        </p:scale>
        <p:origin x="138" y="43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4EB3A6-CE32-4EB7-97B3-EF5A376E9ACA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4A5335-118E-4E50-837C-ABAD7364A0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1546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AD13EC-AEF3-42D6-9E06-EC8BFD806C96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0466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78CAB92-EDFE-42CD-9D3E-66195E8747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1CB7E94C-3CC3-4023-8D49-0BFD0301EB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49C14BD-2582-4ABF-A3C6-3EDA4385E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BEC817A-4F91-4044-A446-D1654F9E4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2FCFC8-2C55-4F7D-AE5F-D0FEE105E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3147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0FEDB5-3E1B-42EF-BC88-5DE1DDA725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50426399-E822-429D-B0ED-B426E0904B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723C629-3C35-424B-8633-898C28C6A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25C7CD9-D24A-4A95-BE9D-87968BDCF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1DE5B4E-5F42-4E27-AF86-E0EDC31CB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865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EED46BC-3765-4941-BFBC-10E95B6D2F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E04F861-B3D7-44AE-83FD-457A16438F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FD7ED0A-B829-44AD-BBE9-9C7E5F6D8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BD6F1A1-823F-4564-AAF6-640227E2A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A1AF836-9A24-4889-A3FF-5BE349013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61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0527B74-AC78-4D5C-A7CE-FFBB588A82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5175519-A31B-4136-9994-D50AD5D897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2803229-54A4-4D47-80C6-7E4F59E21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EFC2177-61F1-4922-88C5-32E30496F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B8732A6-701D-47DD-B758-94B1CA264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3238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AEE7A33-A7E6-47C6-9886-8E10343759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A0E4F6EF-1A2A-44F2-9344-3058577A5D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5C03EF47-5215-482D-9F42-F7C813E8D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4833D13-6B63-45ED-B580-9CBC1BD2F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2529C06-3982-470B-B20D-F9A018074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095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CA9CBD9-2137-4E5B-B954-E0DDCE0DAD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0D2F062-87FC-4E66-82B8-F6EF61774D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EE13A8DD-A83D-444C-B7B3-136C2483C9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EEDEFAF6-CC2D-4C4C-A7A7-7F6B4F140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D043BA9D-2E5B-4640-A211-2CB85DC4E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09EEE8C1-A1E3-4449-8323-56C981D90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1300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9CBEF31-7AEE-4C29-89A6-2707F551B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DEA51375-FBE4-4C34-BBDF-FBE5227E59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86C63EF-B43E-4ED7-98FD-505777300D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28BDB6CB-ADFF-40A8-B45C-554EFC9EA8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AF00A73-63CB-4C95-BBAF-7B535CA5E8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B3E104FE-E347-4E66-A9D0-6B6DA7676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D5B9D3BB-858A-40D6-8D3C-D55951497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4E48CA2F-3607-4729-A734-A3381729B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5728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B7185F9-299D-4204-B651-962A030172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A32444F7-330F-4FB0-B4ED-06F586510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604F28A-ACCA-4ACD-85F9-AE316F311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9ACF28AD-6930-4000-8A54-B808B94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7214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C0E7FF7C-13BC-4378-82B6-E8C5964F2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D19628B2-983B-40C2-9716-DB46F9BAC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FC66A8B0-C6DE-42C5-903E-1EFB51211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543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896F07E-F125-4D9B-B4E3-A466D51E04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8992BA5-BF4D-4436-9741-E71AE8C19F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E7496BB1-9069-4C53-A28D-7041B86EFC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C485298A-D073-4DE2-9A2D-6C5F1659CF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6A09A4C-7D49-4FA0-8BC6-DD0D451B2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FA3CB626-1F80-42B6-9DBE-5B2EF47F8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843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8477417-ACD7-4A08-A9DC-AB75F5614E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B6556C35-5432-4C80-8144-6B7A7B982D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C0078426-F4C8-4D25-BF36-6F58D0A4B4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255CC74-B0ED-4924-B6A7-1738C2D2B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D115439-456F-4E42-95BC-31E889EB8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8DDE6C41-E68B-415E-803B-0BAA6FBBA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046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A1749451-BF0F-43B3-BF9C-B5CE7BE575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C95F3327-B2A5-4865-85C1-44A4FCA06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4800A25-7B84-46CE-B06F-4FD6F88EE2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2560B-A6E3-4CBD-927A-F9A8093AE2C2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BBB99AA-2594-4CB3-9821-507BC7AAC1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8BF212D-53C4-4850-A9EA-04187621E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54CF5-49F3-4D4F-95CD-660AFEAEC2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0842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5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.w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5.w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AD08D98-935E-4A76-9962-5648708BA2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1752" y="1318732"/>
            <a:ext cx="4670164" cy="3949916"/>
          </a:xfrm>
          <a:prstGeom prst="rect">
            <a:avLst/>
          </a:prstGeom>
        </p:spPr>
      </p:pic>
      <p:pic>
        <p:nvPicPr>
          <p:cNvPr id="5" name="图片 4" descr="图片包含 游戏机, 鱼&#10;&#10;描述已自动生成">
            <a:extLst>
              <a:ext uri="{FF2B5EF4-FFF2-40B4-BE49-F238E27FC236}">
                <a16:creationId xmlns:a16="http://schemas.microsoft.com/office/drawing/2014/main" xmlns="" id="{10B1BBFB-A10C-49CE-978B-BA8C4B3E06A6}"/>
              </a:ext>
            </a:extLst>
          </p:cNvPr>
          <p:cNvPicPr preferRelativeResize="0"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6134" y="1333500"/>
            <a:ext cx="4669200" cy="39492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EBA84727-4424-4ABC-AF0B-ADBAF7B16CBA}"/>
              </a:ext>
            </a:extLst>
          </p:cNvPr>
          <p:cNvSpPr txBox="1"/>
          <p:nvPr/>
        </p:nvSpPr>
        <p:spPr>
          <a:xfrm flipH="1">
            <a:off x="1111752" y="1281581"/>
            <a:ext cx="33096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400" b="1" dirty="0">
                <a:latin typeface="+mn-ea"/>
              </a:rPr>
              <a:t>a</a:t>
            </a:r>
            <a:endParaRPr lang="zh-CN" altLang="en-US" sz="2400" b="1" dirty="0">
              <a:latin typeface="+mn-ea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33608C03-BFF6-4B68-BF0D-BCC02A848B46}"/>
              </a:ext>
            </a:extLst>
          </p:cNvPr>
          <p:cNvSpPr txBox="1"/>
          <p:nvPr/>
        </p:nvSpPr>
        <p:spPr>
          <a:xfrm flipH="1">
            <a:off x="5931992" y="1317682"/>
            <a:ext cx="356174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400" b="1" dirty="0">
                <a:latin typeface="+mn-ea"/>
              </a:rPr>
              <a:t>b</a:t>
            </a:r>
            <a:endParaRPr lang="zh-CN" altLang="en-US" sz="2400" b="1" dirty="0">
              <a:latin typeface="+mn-ea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C67788AF-A00F-4C42-BC35-B322CEF452BF}"/>
              </a:ext>
            </a:extLst>
          </p:cNvPr>
          <p:cNvSpPr txBox="1"/>
          <p:nvPr/>
        </p:nvSpPr>
        <p:spPr>
          <a:xfrm>
            <a:off x="81280" y="30480"/>
            <a:ext cx="43937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E30266B5-7C4E-4E9D-BF19-65BABD793661}"/>
              </a:ext>
            </a:extLst>
          </p:cNvPr>
          <p:cNvSpPr txBox="1"/>
          <p:nvPr/>
        </p:nvSpPr>
        <p:spPr>
          <a:xfrm>
            <a:off x="408556" y="751550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3016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23E986CF-B8C6-4CF0-967E-B4411BC28190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583754"/>
            <a:ext cx="4669200" cy="39492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20514BAB-5BF8-4B6D-BDBC-2EFBFAF9AD57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6933" y="1583754"/>
            <a:ext cx="4669200" cy="39492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A0D7C8BC-D29F-4C82-81B0-52D1385C401D}"/>
              </a:ext>
            </a:extLst>
          </p:cNvPr>
          <p:cNvSpPr txBox="1"/>
          <p:nvPr/>
        </p:nvSpPr>
        <p:spPr>
          <a:xfrm flipH="1">
            <a:off x="1176933" y="1583754"/>
            <a:ext cx="360000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400" b="1" dirty="0">
                <a:latin typeface="+mn-ea"/>
              </a:rPr>
              <a:t>a</a:t>
            </a:r>
            <a:endParaRPr lang="zh-CN" altLang="en-US" sz="2400" b="1" dirty="0">
              <a:latin typeface="+mn-ea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D041422F-0241-4A1E-8319-0D3FE8B2C228}"/>
              </a:ext>
            </a:extLst>
          </p:cNvPr>
          <p:cNvSpPr txBox="1"/>
          <p:nvPr/>
        </p:nvSpPr>
        <p:spPr>
          <a:xfrm flipH="1">
            <a:off x="6096000" y="1583754"/>
            <a:ext cx="356174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400" b="1" dirty="0">
                <a:latin typeface="+mn-ea"/>
              </a:rPr>
              <a:t>b</a:t>
            </a:r>
            <a:endParaRPr lang="zh-CN" altLang="en-US" sz="2400" b="1" dirty="0">
              <a:latin typeface="+mn-ea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8CF5A37A-7749-4A0B-8E3D-297715421358}"/>
              </a:ext>
            </a:extLst>
          </p:cNvPr>
          <p:cNvSpPr txBox="1"/>
          <p:nvPr/>
        </p:nvSpPr>
        <p:spPr>
          <a:xfrm>
            <a:off x="243840" y="59657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88033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xmlns="" id="{0A83DA09-2CE7-4653-AF3F-F7CE1A36DBE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0456" y="396105"/>
          <a:ext cx="7328848" cy="49790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1" name="Graph" r:id="rId3" imgW="3911040" imgH="2657520" progId="Origin50.Graph">
                  <p:embed/>
                </p:oleObj>
              </mc:Choice>
              <mc:Fallback>
                <p:oleObj name="Graph" r:id="rId3" imgW="3911040" imgH="2657520" progId="Origin50.Graph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xmlns="" id="{0A83DA09-2CE7-4653-AF3F-F7CE1A36DB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60456" y="396105"/>
                        <a:ext cx="7328848" cy="49790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125C257B-6E30-48DA-BEBD-39C8B3B27CD8}"/>
              </a:ext>
            </a:extLst>
          </p:cNvPr>
          <p:cNvSpPr txBox="1"/>
          <p:nvPr/>
        </p:nvSpPr>
        <p:spPr>
          <a:xfrm>
            <a:off x="243840" y="59657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09481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112DF4EA-7155-457B-AFE5-FBD481404DCC}"/>
              </a:ext>
            </a:extLst>
          </p:cNvPr>
          <p:cNvSpPr txBox="1"/>
          <p:nvPr/>
        </p:nvSpPr>
        <p:spPr>
          <a:xfrm>
            <a:off x="243840" y="59657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xmlns="" id="{BEB83C9F-F458-4A03-980C-BB0E0FB580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2063087"/>
              </p:ext>
            </p:extLst>
          </p:nvPr>
        </p:nvGraphicFramePr>
        <p:xfrm>
          <a:off x="1981200" y="781245"/>
          <a:ext cx="7412182" cy="50357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5" name="Graph" r:id="rId3" imgW="3911040" imgH="2657520" progId="Origin50.Graph">
                  <p:embed/>
                </p:oleObj>
              </mc:Choice>
              <mc:Fallback>
                <p:oleObj name="Graph" r:id="rId3" imgW="3911040" imgH="265752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81200" y="781245"/>
                        <a:ext cx="7412182" cy="50357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881881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79FBD42E-E652-49BF-8C74-F02898A23E3C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751214" y="781244"/>
            <a:ext cx="7559041" cy="527319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E782EBD1-25F2-48E6-A066-621F1764FB78}"/>
              </a:ext>
            </a:extLst>
          </p:cNvPr>
          <p:cNvSpPr txBox="1"/>
          <p:nvPr/>
        </p:nvSpPr>
        <p:spPr>
          <a:xfrm>
            <a:off x="243840" y="59657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9007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31">
            <a:extLst>
              <a:ext uri="{FF2B5EF4-FFF2-40B4-BE49-F238E27FC236}">
                <a16:creationId xmlns:a16="http://schemas.microsoft.com/office/drawing/2014/main" xmlns="" id="{3FD0DBD9-BC25-4B35-8E40-0BEF004657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5969" y="335035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7" name="Rectangle 32">
            <a:extLst>
              <a:ext uri="{FF2B5EF4-FFF2-40B4-BE49-F238E27FC236}">
                <a16:creationId xmlns:a16="http://schemas.microsoft.com/office/drawing/2014/main" xmlns="" id="{7D1B69AA-0820-4E94-B7BB-6AD0A8C115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14655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5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5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                 </a:t>
            </a:r>
            <a:endParaRPr kumimoji="0" lang="en-US" altLang="zh-CN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33">
            <a:extLst>
              <a:ext uri="{FF2B5EF4-FFF2-40B4-BE49-F238E27FC236}">
                <a16:creationId xmlns:a16="http://schemas.microsoft.com/office/drawing/2014/main" xmlns="" id="{F15FE4AB-A997-4BD1-8B5E-FD9FDE4439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0875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3098" name="图片 202">
            <a:extLst>
              <a:ext uri="{FF2B5EF4-FFF2-40B4-BE49-F238E27FC236}">
                <a16:creationId xmlns:a16="http://schemas.microsoft.com/office/drawing/2014/main" xmlns="" id="{150663AE-8B66-4084-90ED-4B0F91DC69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6655" y="1023583"/>
            <a:ext cx="2292066" cy="17073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7" name="图片 203">
            <a:extLst>
              <a:ext uri="{FF2B5EF4-FFF2-40B4-BE49-F238E27FC236}">
                <a16:creationId xmlns:a16="http://schemas.microsoft.com/office/drawing/2014/main" xmlns="" id="{6E549A45-AD4D-4F79-8119-3CCDC3299C8F}"/>
              </a:ext>
            </a:extLst>
          </p:cNvPr>
          <p:cNvPicPr preferRelativeResize="0"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0154" y="1020686"/>
            <a:ext cx="2267002" cy="17090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6" name="图片 201">
            <a:extLst>
              <a:ext uri="{FF2B5EF4-FFF2-40B4-BE49-F238E27FC236}">
                <a16:creationId xmlns:a16="http://schemas.microsoft.com/office/drawing/2014/main" xmlns="" id="{C473E51E-DA66-47C4-BC0E-97D888607F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0722" y="1027003"/>
            <a:ext cx="2289432" cy="17027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5" name="图片 204">
            <a:extLst>
              <a:ext uri="{FF2B5EF4-FFF2-40B4-BE49-F238E27FC236}">
                <a16:creationId xmlns:a16="http://schemas.microsoft.com/office/drawing/2014/main" xmlns="" id="{380B3B0B-87AF-4688-BBA8-CDA9EEF3CB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0720" y="2766237"/>
            <a:ext cx="3513424" cy="25372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9" name="图片 9">
            <a:extLst>
              <a:ext uri="{FF2B5EF4-FFF2-40B4-BE49-F238E27FC236}">
                <a16:creationId xmlns:a16="http://schemas.microsoft.com/office/drawing/2014/main" xmlns="" id="{276EB231-2013-4BCF-A60A-955AA5B1D2FC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7264" y="2764915"/>
            <a:ext cx="3225726" cy="25386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xmlns="" id="{CFB5294F-5BCA-4872-82FD-D1144D4A68A4}"/>
              </a:ext>
            </a:extLst>
          </p:cNvPr>
          <p:cNvSpPr txBox="1"/>
          <p:nvPr/>
        </p:nvSpPr>
        <p:spPr>
          <a:xfrm flipH="1">
            <a:off x="1955639" y="989241"/>
            <a:ext cx="320649" cy="400111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000" b="1" dirty="0">
                <a:latin typeface="+mn-ea"/>
              </a:rPr>
              <a:t>a</a:t>
            </a:r>
            <a:endParaRPr lang="zh-CN" altLang="en-US" sz="2000" b="1" dirty="0">
              <a:latin typeface="+mn-ea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4A6D6EE2-0863-40A6-8F46-E09C01A3F8E8}"/>
              </a:ext>
            </a:extLst>
          </p:cNvPr>
          <p:cNvSpPr txBox="1"/>
          <p:nvPr/>
        </p:nvSpPr>
        <p:spPr>
          <a:xfrm flipH="1">
            <a:off x="5577264" y="2763692"/>
            <a:ext cx="320649" cy="400111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000" b="1" dirty="0">
                <a:latin typeface="+mn-ea"/>
              </a:rPr>
              <a:t>c</a:t>
            </a:r>
            <a:endParaRPr lang="zh-CN" altLang="en-US" sz="2000" b="1" dirty="0">
              <a:latin typeface="+mn-ea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xmlns="" id="{41E7F67E-BA1D-4465-B6A8-2DBFDD5ACE72}"/>
              </a:ext>
            </a:extLst>
          </p:cNvPr>
          <p:cNvSpPr txBox="1"/>
          <p:nvPr/>
        </p:nvSpPr>
        <p:spPr>
          <a:xfrm flipH="1">
            <a:off x="1941222" y="2729721"/>
            <a:ext cx="320649" cy="400111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000" b="1" dirty="0">
                <a:latin typeface="+mn-ea"/>
              </a:rPr>
              <a:t>b</a:t>
            </a:r>
            <a:endParaRPr lang="zh-CN" altLang="en-US" sz="2000" b="1" dirty="0">
              <a:latin typeface="+mn-ea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1270ED95-2FCD-412D-B030-80A17018B4A5}"/>
              </a:ext>
            </a:extLst>
          </p:cNvPr>
          <p:cNvSpPr txBox="1"/>
          <p:nvPr/>
        </p:nvSpPr>
        <p:spPr>
          <a:xfrm>
            <a:off x="243840" y="59657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30750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xmlns="" id="{679F5C15-DF46-4B79-8C0E-E8A6B5A86E80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5310147" y="3429000"/>
            <a:ext cx="1219397" cy="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C9F1C58B-B6A5-4DF4-8C16-FCE22023664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840" y="1707322"/>
            <a:ext cx="4812307" cy="344335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B177E3BD-14B6-4C0E-87E8-9879A09BFF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9544" y="1707328"/>
            <a:ext cx="4955430" cy="3443349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xmlns="" id="{7CEA3B20-11E7-46FB-B185-AD7769930EB0}"/>
              </a:ext>
            </a:extLst>
          </p:cNvPr>
          <p:cNvSpPr/>
          <p:nvPr/>
        </p:nvSpPr>
        <p:spPr>
          <a:xfrm>
            <a:off x="5414739" y="3028886"/>
            <a:ext cx="101021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etch</a:t>
            </a:r>
            <a:endParaRPr lang="zh-CN" altLang="en-US" sz="2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A1EF2222-5E93-4C05-A0BC-C28C8F170547}"/>
              </a:ext>
            </a:extLst>
          </p:cNvPr>
          <p:cNvSpPr txBox="1"/>
          <p:nvPr/>
        </p:nvSpPr>
        <p:spPr>
          <a:xfrm>
            <a:off x="243840" y="59657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41443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xmlns="" id="{A05D9452-308C-491B-931B-56858312AF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8755063"/>
              </p:ext>
            </p:extLst>
          </p:nvPr>
        </p:nvGraphicFramePr>
        <p:xfrm>
          <a:off x="2128519" y="771525"/>
          <a:ext cx="7266222" cy="49365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9" name="Graph" r:id="rId3" imgW="3911040" imgH="2657520" progId="Origin50.Graph">
                  <p:embed/>
                </p:oleObj>
              </mc:Choice>
              <mc:Fallback>
                <p:oleObj name="Graph" r:id="rId3" imgW="3911040" imgH="2657520" progId="Origin50.Graph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xmlns="" id="{A05D9452-308C-491B-931B-56858312AF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28519" y="771525"/>
                        <a:ext cx="7266222" cy="49365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E30266B5-7C4E-4E9D-BF19-65BABD793661}"/>
              </a:ext>
            </a:extLst>
          </p:cNvPr>
          <p:cNvSpPr txBox="1"/>
          <p:nvPr/>
        </p:nvSpPr>
        <p:spPr>
          <a:xfrm>
            <a:off x="391159" y="586859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79206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92710BBB-8D3A-40B1-927E-888484E56A70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73724" y="1219700"/>
            <a:ext cx="6860075" cy="4659134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15704E23-387C-4FEE-BA7D-9182C2B9D815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429" y="1219700"/>
            <a:ext cx="6860075" cy="4659134"/>
          </a:xfrm>
          <a:prstGeom prst="rect">
            <a:avLst/>
          </a:prstGeom>
          <a:noFill/>
        </p:spPr>
      </p:pic>
      <p:sp>
        <p:nvSpPr>
          <p:cNvPr id="8" name="文本框 5">
            <a:extLst>
              <a:ext uri="{FF2B5EF4-FFF2-40B4-BE49-F238E27FC236}">
                <a16:creationId xmlns:a16="http://schemas.microsoft.com/office/drawing/2014/main" xmlns="" id="{A0D7C8BC-D29F-4C82-81B0-52D1385C401D}"/>
              </a:ext>
            </a:extLst>
          </p:cNvPr>
          <p:cNvSpPr txBox="1"/>
          <p:nvPr/>
        </p:nvSpPr>
        <p:spPr>
          <a:xfrm flipH="1">
            <a:off x="3496" y="1574436"/>
            <a:ext cx="360000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400" b="1" dirty="0">
                <a:latin typeface="+mn-ea"/>
              </a:rPr>
              <a:t>a</a:t>
            </a:r>
            <a:endParaRPr lang="zh-CN" altLang="en-US" sz="2400" b="1" dirty="0">
              <a:latin typeface="+mn-ea"/>
            </a:endParaRPr>
          </a:p>
        </p:txBody>
      </p:sp>
      <p:sp>
        <p:nvSpPr>
          <p:cNvPr id="9" name="文本框 6">
            <a:extLst>
              <a:ext uri="{FF2B5EF4-FFF2-40B4-BE49-F238E27FC236}">
                <a16:creationId xmlns:a16="http://schemas.microsoft.com/office/drawing/2014/main" xmlns="" id="{D041422F-0241-4A1E-8319-0D3FE8B2C228}"/>
              </a:ext>
            </a:extLst>
          </p:cNvPr>
          <p:cNvSpPr txBox="1"/>
          <p:nvPr/>
        </p:nvSpPr>
        <p:spPr>
          <a:xfrm flipH="1">
            <a:off x="5435943" y="1574436"/>
            <a:ext cx="356174" cy="360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400" b="1" dirty="0">
                <a:latin typeface="+mn-ea"/>
              </a:rPr>
              <a:t>b</a:t>
            </a:r>
            <a:endParaRPr lang="zh-CN" altLang="en-US" sz="2400" b="1" dirty="0">
              <a:latin typeface="+mn-ea"/>
            </a:endParaRPr>
          </a:p>
        </p:txBody>
      </p:sp>
      <p:sp>
        <p:nvSpPr>
          <p:cNvPr id="6" name="文本框 2">
            <a:extLst>
              <a:ext uri="{FF2B5EF4-FFF2-40B4-BE49-F238E27FC236}">
                <a16:creationId xmlns:a16="http://schemas.microsoft.com/office/drawing/2014/main" xmlns="" id="{E30266B5-7C4E-4E9D-BF19-65BABD793661}"/>
              </a:ext>
            </a:extLst>
          </p:cNvPr>
          <p:cNvSpPr txBox="1"/>
          <p:nvPr/>
        </p:nvSpPr>
        <p:spPr>
          <a:xfrm>
            <a:off x="183496" y="609834"/>
            <a:ext cx="1737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6203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5</TotalTime>
  <Words>32</Words>
  <Application>Microsoft Office PowerPoint</Application>
  <PresentationFormat>Widescreen</PresentationFormat>
  <Paragraphs>23</Paragraphs>
  <Slides>9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Times New Roman</vt:lpstr>
      <vt:lpstr>等线</vt:lpstr>
      <vt:lpstr>等线 Light</vt:lpstr>
      <vt:lpstr>Office 主题​​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石 幂</dc:creator>
  <cp:lastModifiedBy>Lakshmi Priya S.</cp:lastModifiedBy>
  <cp:revision>12</cp:revision>
  <dcterms:created xsi:type="dcterms:W3CDTF">2020-06-26T09:29:50Z</dcterms:created>
  <dcterms:modified xsi:type="dcterms:W3CDTF">2020-06-29T13:11:16Z</dcterms:modified>
</cp:coreProperties>
</file>